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4" d="100"/>
          <a:sy n="104" d="100"/>
        </p:scale>
        <p:origin x="-222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289F83-B080-49E8-87E4-3EF2BEC70377}" type="datetimeFigureOut">
              <a:rPr lang="en-US" smtClean="0"/>
              <a:pPr/>
              <a:t>1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C0CDE7-DDA7-4566-8DEC-C1DCE0D0924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-396553" y="44624"/>
            <a:ext cx="10336783" cy="5976664"/>
          </a:xfrm>
          <a:prstGeom prst="rect">
            <a:avLst/>
          </a:prstGeom>
        </p:spPr>
      </p:pic>
      <p:sp>
        <p:nvSpPr>
          <p:cNvPr id="34" name="Rectangle 33"/>
          <p:cNvSpPr/>
          <p:nvPr/>
        </p:nvSpPr>
        <p:spPr>
          <a:xfrm>
            <a:off x="107504" y="5445224"/>
            <a:ext cx="903649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ure S1. Sequence data filtering and database mapping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 total of 15,749,022 reads were initially processed by removing low quality sequence reads.  The remaining 15,623,905 high quality sequences were further processed by removing sequences shorter than 15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and longer than 26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, and sequences with copy numbers smaller than three.  Finally, other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noncoding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RNAs including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rRNA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tRNA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snRNA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snoRNA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, and degraded mRNAs were removed by blasting various related databases.  The resulting 2,098,391 sequences were kept as candidates for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miRN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analysis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750301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9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ng</dc:creator>
  <cp:lastModifiedBy>M CHEN</cp:lastModifiedBy>
  <cp:revision>14</cp:revision>
  <dcterms:created xsi:type="dcterms:W3CDTF">2012-08-11T12:34:40Z</dcterms:created>
  <dcterms:modified xsi:type="dcterms:W3CDTF">2013-01-04T22:42:19Z</dcterms:modified>
</cp:coreProperties>
</file>